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7"/>
  </p:normalViewPr>
  <p:slideViewPr>
    <p:cSldViewPr snapToGrid="0">
      <p:cViewPr varScale="1">
        <p:scale>
          <a:sx n="123" d="100"/>
          <a:sy n="123" d="100"/>
        </p:scale>
        <p:origin x="720" y="7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4CF370-6CE7-AEE6-389F-29773344B19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EBEB375-CADC-3469-51CF-04F797B7060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zh-CN"/>
              <a:t>Click to edit Master subtitle style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3A6D72-4186-8DF4-31F4-E7620F35AA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358AB-589A-4102-8730-E59569818636}" type="datetimeFigureOut">
              <a:rPr lang="zh-CN" altLang="en-US" smtClean="0"/>
              <a:t>2026/2/18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3AB2CA-29E4-8DA2-23A7-874356CD07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CA079B-7468-8285-C54E-55574EA573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0B246-4C9E-4B90-8766-017AB5A16A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7644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C3FCFE-E81A-660E-D0E2-59A0E00A33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3FF7FC4-6780-18FB-9B69-7AE82F4E10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864258-A202-7D50-5323-3BB27B28E9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358AB-589A-4102-8730-E59569818636}" type="datetimeFigureOut">
              <a:rPr lang="zh-CN" altLang="en-US" smtClean="0"/>
              <a:t>2026/2/18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B335C4-F7E4-E334-91FF-C9FBE1FEBC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741591-D6F2-E569-6CE9-31A9CCDD93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0B246-4C9E-4B90-8766-017AB5A16A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50944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2E6D4A5-11C3-7D93-D409-7E0CB7A8F43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60529A3-B2D2-7CF7-9B31-C5F03D1812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CA1C1E-E8F1-1D88-61A4-850B2B5454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358AB-589A-4102-8730-E59569818636}" type="datetimeFigureOut">
              <a:rPr lang="zh-CN" altLang="en-US" smtClean="0"/>
              <a:t>2026/2/18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7ADD6C-A083-21C7-37E6-FA2B6B32AF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991B47-A6B8-BB8A-904C-0A4B45E759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0B246-4C9E-4B90-8766-017AB5A16A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64412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D6FA2A-7998-0AB0-0CE4-151831E0BD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0D3EFF-1266-2367-9A7A-AD76A835851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3AADD9-53FE-BD8E-D4DB-C3D90B06DE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358AB-589A-4102-8730-E59569818636}" type="datetimeFigureOut">
              <a:rPr lang="zh-CN" altLang="en-US" smtClean="0"/>
              <a:t>2026/2/18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2EB335-B6C1-7FC9-53B9-F58A9ED046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EE9A99-6455-0F4B-0008-5D8D2418EC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0B246-4C9E-4B90-8766-017AB5A16A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51602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A7A44A-7BDA-436F-B121-6C1A41904D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90CA3CC-8876-7083-B9DA-72ED6E9265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871850-3A40-5F20-F2BC-99346ADB0A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358AB-589A-4102-8730-E59569818636}" type="datetimeFigureOut">
              <a:rPr lang="zh-CN" altLang="en-US" smtClean="0"/>
              <a:t>2026/2/18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6D808D-C5E8-0EA7-CE39-93A58FF586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12F284-D3F2-8340-127A-0C4A279C0F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0B246-4C9E-4B90-8766-017AB5A16A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86503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66E8CE-B64F-E9A5-171D-4F24B12EE8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BE69DDD-9D2F-784A-C6AB-B5FAE7CEB8C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4ED547B-4DAA-2231-75E3-0800C47877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8E7A6F-0921-B161-EA86-6C17B01C05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358AB-589A-4102-8730-E59569818636}" type="datetimeFigureOut">
              <a:rPr lang="zh-CN" altLang="en-US" smtClean="0"/>
              <a:t>2026/2/18</a:t>
            </a:fld>
            <a:endParaRPr lang="zh-CN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DA3D2A8-886B-567B-780C-6051C4C374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12EE4C4-CF89-0221-88C7-D6684635A3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0B246-4C9E-4B90-8766-017AB5A16A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60669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674174-CAB4-CDA7-9020-EF2238F66F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E8C7096-66D0-771D-F9EE-70C9F0CD95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FDBC48-B4B1-6545-F9B1-BCBEB48E25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F0C0D25-EAB8-1962-746C-2CABA4E477A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25A0F26-4A50-67CB-5D47-B7F9EF546CB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43A42BF-98D0-89AD-D947-D5116C69CA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358AB-589A-4102-8730-E59569818636}" type="datetimeFigureOut">
              <a:rPr lang="zh-CN" altLang="en-US" smtClean="0"/>
              <a:t>2026/2/18</a:t>
            </a:fld>
            <a:endParaRPr lang="zh-CN" alt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F86CAF9-C36E-0476-CD6F-57C1D75B92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D09B67D-BFFF-CFEB-D7A7-CE1AF4624C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0B246-4C9E-4B90-8766-017AB5A16A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63851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54E943-3113-3E00-DA9F-7CA37DF34A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B7697F3-B33D-D938-7DEC-DA208521F5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358AB-589A-4102-8730-E59569818636}" type="datetimeFigureOut">
              <a:rPr lang="zh-CN" altLang="en-US" smtClean="0"/>
              <a:t>2026/2/18</a:t>
            </a:fld>
            <a:endParaRPr lang="zh-CN" alt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09F92D2-24E2-F1F0-B4E4-A1482FE082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D9F0452-42A4-0407-9789-0DBBCD2C7E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0B246-4C9E-4B90-8766-017AB5A16A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05376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E75FA6A-1328-0874-DCBB-C7B06AB5F3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358AB-589A-4102-8730-E59569818636}" type="datetimeFigureOut">
              <a:rPr lang="zh-CN" altLang="en-US" smtClean="0"/>
              <a:t>2026/2/18</a:t>
            </a:fld>
            <a:endParaRPr lang="zh-CN" alt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5C1BA42-516D-E2E8-ADC5-3E2ACEBADC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28F8F67-86B5-97CD-BA4B-19609D3901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0B246-4C9E-4B90-8766-017AB5A16A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44961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55C88A-93E5-C9C0-FB78-69869C8C22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614836-3D0D-70C5-394D-3E43C967659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F117D52-F541-B969-0519-83700910C1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A2AA7BC-9319-65DE-695D-1D7853ABE2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358AB-589A-4102-8730-E59569818636}" type="datetimeFigureOut">
              <a:rPr lang="zh-CN" altLang="en-US" smtClean="0"/>
              <a:t>2026/2/18</a:t>
            </a:fld>
            <a:endParaRPr lang="zh-CN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92FE010-998A-F313-78EB-A44DD3C007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281C621-0488-39D5-3E74-523E0E49DA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0B246-4C9E-4B90-8766-017AB5A16A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4515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1601A8-928D-5276-F7DB-8B67516959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8B52BE4-E42F-517E-38FE-23585CCBE0B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BB21DA9-CD58-00F2-9202-57803DDA42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54A263-A32B-567D-0FF5-737E54FF00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358AB-589A-4102-8730-E59569818636}" type="datetimeFigureOut">
              <a:rPr lang="zh-CN" altLang="en-US" smtClean="0"/>
              <a:t>2026/2/18</a:t>
            </a:fld>
            <a:endParaRPr lang="zh-CN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B5B0B9-E5B3-E19E-0371-41B3CCFF61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D2FE37-A944-A63D-0455-BC7F56DFBF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0B246-4C9E-4B90-8766-017AB5A16A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92910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B34E089-A575-C63D-3873-73B157A95E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F1EFAF-D423-7C91-61FA-89889066D5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B55601-59B2-165D-A105-3E3CBE99513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01358AB-589A-4102-8730-E59569818636}" type="datetimeFigureOut">
              <a:rPr lang="zh-CN" altLang="en-US" smtClean="0"/>
              <a:t>2026/2/18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7BA2DF-371E-0852-729B-2214FB76777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F6651D-C956-D6F2-6C06-B8512454912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4B0B246-4C9E-4B90-8766-017AB5A16A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0047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B260900D-F968-0F61-0DB3-9CEE07502272}"/>
              </a:ext>
            </a:extLst>
          </p:cNvPr>
          <p:cNvSpPr txBox="1"/>
          <p:nvPr/>
        </p:nvSpPr>
        <p:spPr>
          <a:xfrm>
            <a:off x="78881" y="5058520"/>
            <a:ext cx="12079088" cy="18158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CN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</a:t>
            </a:r>
            <a:r>
              <a:rPr lang="en-CN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lang="en-CN" sz="1400" b="1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Upper panel</a:t>
            </a:r>
            <a:r>
              <a:rPr lang="en-CN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Weekly daily food intake (g per BW) distributions shown as boxplots (weeks 1–12) with pairwise between-group comparisons annotated above brackets; </a:t>
            </a:r>
            <a:r>
              <a:rPr lang="en-CN" sz="1400" b="1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ower panel</a:t>
            </a:r>
            <a:r>
              <a:rPr lang="en-CN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Weekly daily food intake (g per BW) partitioned by circadian phase (inactive/light phase 07:00–19:00; active/dark phase 19:00–07:00), where within each week the upper brackets/</a:t>
            </a:r>
            <a:r>
              <a:rPr lang="en-CN" sz="14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CN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-values compare whole-day (24 h) total intake between groups and the lower brackets/</a:t>
            </a:r>
            <a:r>
              <a:rPr lang="en-CN" sz="14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CN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-values compare inactive vs active intake within each group (red </a:t>
            </a:r>
            <a:r>
              <a:rPr lang="en-CN" sz="14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CN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-values indicate </a:t>
            </a:r>
            <a:r>
              <a:rPr lang="en-CN" sz="14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CN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&lt; 0.05 as displayed); G, End-point plasma HDL-C, LDL-C, triglycerides (TG), total cholesterol (TC), and malondialdehyde (MDA) across groups (units as indicated on axes). Group colors follow Ctrl (red), D−N+ (green), and D+N− (blue) and intake time colors follow Inactive Phase (red) and Active Phase (blue). Boxplots show median and interquartile range (IQR), whiskers extend to 1.5×IQR, and points/black dots indicate individual values and outliers beyond whiskers where shown; pairwise statistics were computed using two-sided t-tests 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ith holm </a:t>
            </a:r>
            <a:r>
              <a:rPr lang="en-US" sz="14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-value adjust</a:t>
            </a:r>
            <a:r>
              <a:rPr lang="en-CN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</a:t>
            </a:r>
            <a:endParaRPr lang="en-CN" sz="14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pSp>
        <p:nvGrpSpPr>
          <p:cNvPr id="74" name="Group 73">
            <a:extLst>
              <a:ext uri="{FF2B5EF4-FFF2-40B4-BE49-F238E27FC236}">
                <a16:creationId xmlns:a16="http://schemas.microsoft.com/office/drawing/2014/main" id="{9E61B915-2350-1EDE-CC65-3D184A5CD9EB}"/>
              </a:ext>
            </a:extLst>
          </p:cNvPr>
          <p:cNvGrpSpPr/>
          <p:nvPr/>
        </p:nvGrpSpPr>
        <p:grpSpPr>
          <a:xfrm>
            <a:off x="0" y="110730"/>
            <a:ext cx="12192000" cy="4947790"/>
            <a:chOff x="0" y="-8020"/>
            <a:chExt cx="12192000" cy="4947790"/>
          </a:xfrm>
        </p:grpSpPr>
        <p:pic>
          <p:nvPicPr>
            <p:cNvPr id="73" name="Picture 72">
              <a:extLst>
                <a:ext uri="{FF2B5EF4-FFF2-40B4-BE49-F238E27FC236}">
                  <a16:creationId xmlns:a16="http://schemas.microsoft.com/office/drawing/2014/main" id="{A5291FD1-5C1A-CF0C-1FCE-972B3A493AB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8600" y="-8020"/>
              <a:ext cx="11963400" cy="2769305"/>
            </a:xfrm>
            <a:prstGeom prst="rect">
              <a:avLst/>
            </a:prstGeom>
          </p:spPr>
        </p:pic>
        <p:pic>
          <p:nvPicPr>
            <p:cNvPr id="55" name="Picture 54">
              <a:extLst>
                <a:ext uri="{FF2B5EF4-FFF2-40B4-BE49-F238E27FC236}">
                  <a16:creationId xmlns:a16="http://schemas.microsoft.com/office/drawing/2014/main" id="{63D9BF15-A079-2288-A3CA-FDFA6756A82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5358" b="-1"/>
            <a:stretch>
              <a:fillRect/>
            </a:stretch>
          </p:blipFill>
          <p:spPr>
            <a:xfrm>
              <a:off x="0" y="4493456"/>
              <a:ext cx="12192000" cy="446314"/>
            </a:xfrm>
            <a:prstGeom prst="rect">
              <a:avLst/>
            </a:prstGeom>
          </p:spPr>
        </p:pic>
        <p:pic>
          <p:nvPicPr>
            <p:cNvPr id="69" name="Picture 68">
              <a:extLst>
                <a:ext uri="{FF2B5EF4-FFF2-40B4-BE49-F238E27FC236}">
                  <a16:creationId xmlns:a16="http://schemas.microsoft.com/office/drawing/2014/main" id="{318D69F4-05ED-08B6-DC6B-D085BDCAA59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1243" y="2323245"/>
              <a:ext cx="11381014" cy="2107596"/>
            </a:xfrm>
            <a:prstGeom prst="rect">
              <a:avLst/>
            </a:prstGeom>
          </p:spPr>
        </p:pic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58D6F374-D640-48D7-31BB-20D21707115D}"/>
                </a:ext>
              </a:extLst>
            </p:cNvPr>
            <p:cNvSpPr txBox="1"/>
            <p:nvPr/>
          </p:nvSpPr>
          <p:spPr>
            <a:xfrm rot="16200000">
              <a:off x="-1040688" y="2996879"/>
              <a:ext cx="2839303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Food Intake during </a:t>
              </a:r>
            </a:p>
            <a:p>
              <a:pPr algn="ctr"/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Active &amp; Inactive Phases</a:t>
              </a:r>
              <a:b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(g per BW)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927351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B8390C58-2C17-7904-075B-45BCEB666D33}"/>
              </a:ext>
            </a:extLst>
          </p:cNvPr>
          <p:cNvSpPr txBox="1"/>
          <p:nvPr/>
        </p:nvSpPr>
        <p:spPr>
          <a:xfrm>
            <a:off x="152388" y="4611914"/>
            <a:ext cx="11887223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Figure S2. Hepatic redox-related indices in Ctrl, D–N+, and D+N– groups. Box-and-scatter plots showing liver concentrations or activities of reduced glutathione (GSH, µmol/L), oxidized glutathione (GSSG, µmol/L), total glutathione (T-GSH, µmol/L), the GSH/GSSG ratio, and total superoxide dismutase (T-SOD, µU/mg protein) in the three experimental groups (Ctrl, D–N+, and D+N–).</a:t>
            </a:r>
          </a:p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ata are presented as boxplots indicating the median and interquartile range, with whiskers representing the minimum and maximum values. Individual data points represent biological replicates. Adjusted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-values from pairwise comparisons are displayed above the brackets, and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-values &lt; 0.05 are highlighted in red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7B260FF-3142-6BEE-16C1-E2BF9387150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417" y="678694"/>
            <a:ext cx="11887224" cy="38404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10320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74</TotalTime>
  <Words>367</Words>
  <Application>Microsoft Office PowerPoint</Application>
  <PresentationFormat>Widescreen</PresentationFormat>
  <Paragraphs>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UAI YU</dc:creator>
  <cp:lastModifiedBy>KUAI YU</cp:lastModifiedBy>
  <cp:revision>41</cp:revision>
  <dcterms:created xsi:type="dcterms:W3CDTF">2026-02-10T14:33:33Z</dcterms:created>
  <dcterms:modified xsi:type="dcterms:W3CDTF">2026-02-18T01:59:17Z</dcterms:modified>
</cp:coreProperties>
</file>